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9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EPCAM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4mzv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4mzv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57158" y="214291"/>
            <a:ext cx="3286148" cy="30003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97570" y="171451"/>
            <a:ext cx="2632387" cy="304323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57159" y="3357562"/>
            <a:ext cx="3286147" cy="26432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424308" y="3357562"/>
            <a:ext cx="2576716" cy="257176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3</cp:revision>
  <dcterms:created xsi:type="dcterms:W3CDTF">2018-05-10T07:33:24Z</dcterms:created>
  <dcterms:modified xsi:type="dcterms:W3CDTF">2018-05-29T06:59:49Z</dcterms:modified>
</cp:coreProperties>
</file>